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-99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91991D-4DD5-4621-8C6A-1734FD610E30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9A506A-03C0-4133-951D-A051556C4B3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745928-6F93-4FEB-9B0E-25F89DA80FCB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965423-9D52-4C54-9BD0-BB0E034FFAF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6651D2-5464-4DFE-BF06-51D6D241CAFA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18A2EA-E512-45CA-94F1-8B27C8F7003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A2170B-40D4-4E26-8157-743FC83AB27C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38FF22-4B0B-47D1-91EF-5CF5C479B38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DB3889-6045-4FFB-A049-EE77181910D6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6C956C-2D34-4B6B-B946-AB603C96615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15BFA0-917D-4F5E-A138-DF345FAB20DC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FF437E-EB09-44DB-AB46-A4AA374F994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C99376-FC06-4B0A-8FDE-19EA14CB5F2F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4C65DC-ED0F-4102-ABBD-3AE4A62C17F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6F5AAC-0025-4458-A89E-A6FE3B999DF5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1A6B25-8462-41EE-A33B-CA27AF3319D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E2CC31-13B8-4D41-BC2F-F66A46E7424C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7B5C5E-D37E-4B2A-AF06-987037BB65A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840E59-564F-47B4-A1B0-4BBD4A32CA29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F60385-AB98-4CE1-9573-156089B6B94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D42D38-8F7C-484D-8E24-218FFF54C22F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0B1DBA-C102-4B41-AB00-05E7E3C7280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359D637-649B-4F45-BD91-5B2E7B056383}" type="datetimeFigureOut">
              <a:rPr lang="en-GB"/>
              <a:pPr>
                <a:defRPr/>
              </a:pPr>
              <a:t>12/11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0E6BF93-09DE-4D0E-A5A1-16953044548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Oval 132"/>
          <p:cNvSpPr/>
          <p:nvPr/>
        </p:nvSpPr>
        <p:spPr>
          <a:xfrm>
            <a:off x="1259632" y="2204864"/>
            <a:ext cx="3384376" cy="2808312"/>
          </a:xfrm>
          <a:prstGeom prst="ellipse">
            <a:avLst/>
          </a:prstGeom>
          <a:gradFill flip="none" rotWithShape="1">
            <a:gsLst>
              <a:gs pos="0">
                <a:schemeClr val="accent6">
                  <a:lumMod val="40000"/>
                  <a:lumOff val="60000"/>
                </a:schemeClr>
              </a:gs>
              <a:gs pos="30000">
                <a:srgbClr val="D49E6C"/>
              </a:gs>
              <a:gs pos="70000">
                <a:srgbClr val="A65528"/>
              </a:gs>
              <a:gs pos="100000">
                <a:srgbClr val="663012"/>
              </a:gs>
            </a:gsLst>
            <a:path path="circle">
              <a:fillToRect l="100000" t="100000"/>
            </a:path>
            <a:tileRect r="-100000" b="-100000"/>
          </a:gradFill>
          <a:effectLst>
            <a:innerShdw blurRad="635000" dist="1155700" dir="9360000">
              <a:schemeClr val="accent6">
                <a:lumMod val="60000"/>
                <a:lumOff val="40000"/>
                <a:alpha val="50000"/>
              </a:schemeClr>
            </a:innerShdw>
          </a:effectLst>
          <a:scene3d>
            <a:camera prst="orthographicFront"/>
            <a:lightRig rig="balanced" dir="t"/>
          </a:scene3d>
          <a:sp3d prstMaterial="matte">
            <a:bevelT w="19050" h="88900" prst="relaxedInset"/>
            <a:bevelB w="3175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grpSp>
        <p:nvGrpSpPr>
          <p:cNvPr id="3" name="Group 9"/>
          <p:cNvGrpSpPr>
            <a:grpSpLocks/>
          </p:cNvGrpSpPr>
          <p:nvPr/>
        </p:nvGrpSpPr>
        <p:grpSpPr bwMode="auto">
          <a:xfrm rot="1773748">
            <a:off x="1987550" y="2698750"/>
            <a:ext cx="280988" cy="595313"/>
            <a:chOff x="204" y="1728"/>
            <a:chExt cx="472" cy="931"/>
          </a:xfrm>
        </p:grpSpPr>
        <p:sp>
          <p:nvSpPr>
            <p:cNvPr id="43018" name="Oval 10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30" name="Line 11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31" name="Line 12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13"/>
          <p:cNvGrpSpPr>
            <a:grpSpLocks/>
          </p:cNvGrpSpPr>
          <p:nvPr/>
        </p:nvGrpSpPr>
        <p:grpSpPr bwMode="auto">
          <a:xfrm rot="1773748">
            <a:off x="2778125" y="2698750"/>
            <a:ext cx="280988" cy="595313"/>
            <a:chOff x="204" y="1728"/>
            <a:chExt cx="472" cy="931"/>
          </a:xfrm>
        </p:grpSpPr>
        <p:sp>
          <p:nvSpPr>
            <p:cNvPr id="43022" name="Oval 14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27" name="Line 15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28" name="Line 16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5" name="Group 17"/>
          <p:cNvGrpSpPr>
            <a:grpSpLocks/>
          </p:cNvGrpSpPr>
          <p:nvPr/>
        </p:nvGrpSpPr>
        <p:grpSpPr bwMode="auto">
          <a:xfrm rot="1773748">
            <a:off x="3570288" y="2698750"/>
            <a:ext cx="280987" cy="595313"/>
            <a:chOff x="204" y="1728"/>
            <a:chExt cx="472" cy="931"/>
          </a:xfrm>
        </p:grpSpPr>
        <p:sp>
          <p:nvSpPr>
            <p:cNvPr id="43026" name="Oval 18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24" name="Line 19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25" name="Line 20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21"/>
          <p:cNvGrpSpPr>
            <a:grpSpLocks/>
          </p:cNvGrpSpPr>
          <p:nvPr/>
        </p:nvGrpSpPr>
        <p:grpSpPr bwMode="auto">
          <a:xfrm rot="1773748">
            <a:off x="1979613" y="3355975"/>
            <a:ext cx="280987" cy="595313"/>
            <a:chOff x="204" y="1728"/>
            <a:chExt cx="472" cy="931"/>
          </a:xfrm>
        </p:grpSpPr>
        <p:sp>
          <p:nvSpPr>
            <p:cNvPr id="43030" name="Oval 22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21" name="Line 23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22" name="Line 24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25"/>
          <p:cNvGrpSpPr>
            <a:grpSpLocks/>
          </p:cNvGrpSpPr>
          <p:nvPr/>
        </p:nvGrpSpPr>
        <p:grpSpPr bwMode="auto">
          <a:xfrm rot="1773748">
            <a:off x="2770188" y="3355975"/>
            <a:ext cx="280987" cy="595313"/>
            <a:chOff x="204" y="1728"/>
            <a:chExt cx="472" cy="931"/>
          </a:xfrm>
        </p:grpSpPr>
        <p:sp>
          <p:nvSpPr>
            <p:cNvPr id="43034" name="Oval 26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18" name="Line 27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19" name="Line 28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8" name="Group 29"/>
          <p:cNvGrpSpPr>
            <a:grpSpLocks/>
          </p:cNvGrpSpPr>
          <p:nvPr/>
        </p:nvGrpSpPr>
        <p:grpSpPr bwMode="auto">
          <a:xfrm rot="1773748">
            <a:off x="3562350" y="3355975"/>
            <a:ext cx="280988" cy="595313"/>
            <a:chOff x="204" y="1728"/>
            <a:chExt cx="472" cy="931"/>
          </a:xfrm>
        </p:grpSpPr>
        <p:sp>
          <p:nvSpPr>
            <p:cNvPr id="43038" name="Oval 30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15" name="Line 31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16" name="Line 32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9" name="Group 33"/>
          <p:cNvGrpSpPr>
            <a:grpSpLocks/>
          </p:cNvGrpSpPr>
          <p:nvPr/>
        </p:nvGrpSpPr>
        <p:grpSpPr bwMode="auto">
          <a:xfrm rot="1773748">
            <a:off x="1979613" y="3984625"/>
            <a:ext cx="280987" cy="595313"/>
            <a:chOff x="204" y="1728"/>
            <a:chExt cx="472" cy="931"/>
          </a:xfrm>
        </p:grpSpPr>
        <p:sp>
          <p:nvSpPr>
            <p:cNvPr id="43042" name="Oval 34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12" name="Line 35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13" name="Line 36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0" name="Group 37"/>
          <p:cNvGrpSpPr>
            <a:grpSpLocks/>
          </p:cNvGrpSpPr>
          <p:nvPr/>
        </p:nvGrpSpPr>
        <p:grpSpPr bwMode="auto">
          <a:xfrm rot="1773748">
            <a:off x="2770188" y="3984625"/>
            <a:ext cx="280987" cy="595313"/>
            <a:chOff x="204" y="1728"/>
            <a:chExt cx="472" cy="931"/>
          </a:xfrm>
        </p:grpSpPr>
        <p:sp>
          <p:nvSpPr>
            <p:cNvPr id="43046" name="Oval 38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09" name="Line 39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10" name="Line 40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41"/>
          <p:cNvGrpSpPr>
            <a:grpSpLocks/>
          </p:cNvGrpSpPr>
          <p:nvPr/>
        </p:nvGrpSpPr>
        <p:grpSpPr bwMode="auto">
          <a:xfrm rot="1773748">
            <a:off x="3562350" y="3984625"/>
            <a:ext cx="280988" cy="595313"/>
            <a:chOff x="204" y="1728"/>
            <a:chExt cx="472" cy="931"/>
          </a:xfrm>
        </p:grpSpPr>
        <p:sp>
          <p:nvSpPr>
            <p:cNvPr id="43050" name="Oval 42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406" name="Line 43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07" name="Line 44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43053" name="Line 45"/>
          <p:cNvSpPr>
            <a:spLocks noChangeShapeType="1"/>
          </p:cNvSpPr>
          <p:nvPr/>
        </p:nvSpPr>
        <p:spPr bwMode="auto">
          <a:xfrm>
            <a:off x="250825" y="2420938"/>
            <a:ext cx="936625" cy="2303462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26" name="Line 46"/>
          <p:cNvSpPr>
            <a:spLocks noChangeShapeType="1"/>
          </p:cNvSpPr>
          <p:nvPr/>
        </p:nvSpPr>
        <p:spPr bwMode="auto">
          <a:xfrm>
            <a:off x="1403350" y="2000250"/>
            <a:ext cx="331311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  <p:sp>
        <p:nvSpPr>
          <p:cNvPr id="13327" name="Text Box 47"/>
          <p:cNvSpPr txBox="1">
            <a:spLocks noChangeArrowheads="1"/>
          </p:cNvSpPr>
          <p:nvPr/>
        </p:nvSpPr>
        <p:spPr bwMode="auto">
          <a:xfrm>
            <a:off x="1979613" y="1700213"/>
            <a:ext cx="215900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600">
                <a:latin typeface="Calibri" pitchFamily="34" charset="0"/>
              </a:rPr>
              <a:t>Frequency encoding</a:t>
            </a:r>
          </a:p>
        </p:txBody>
      </p:sp>
      <p:sp>
        <p:nvSpPr>
          <p:cNvPr id="13328" name="Text Box 48"/>
          <p:cNvSpPr txBox="1">
            <a:spLocks noChangeArrowheads="1"/>
          </p:cNvSpPr>
          <p:nvPr/>
        </p:nvSpPr>
        <p:spPr bwMode="auto">
          <a:xfrm rot="5400000">
            <a:off x="3829050" y="3044825"/>
            <a:ext cx="215900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600">
                <a:latin typeface="Calibri" pitchFamily="34" charset="0"/>
              </a:rPr>
              <a:t>Phase encoding</a:t>
            </a:r>
          </a:p>
        </p:txBody>
      </p:sp>
      <p:sp>
        <p:nvSpPr>
          <p:cNvPr id="13329" name="Line 49"/>
          <p:cNvSpPr>
            <a:spLocks noChangeShapeType="1"/>
          </p:cNvSpPr>
          <p:nvPr/>
        </p:nvSpPr>
        <p:spPr bwMode="auto">
          <a:xfrm rot="5400000">
            <a:off x="3456782" y="3464719"/>
            <a:ext cx="25193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en-US"/>
          </a:p>
        </p:txBody>
      </p:sp>
      <p:grpSp>
        <p:nvGrpSpPr>
          <p:cNvPr id="12" name="Group 54"/>
          <p:cNvGrpSpPr>
            <a:grpSpLocks/>
          </p:cNvGrpSpPr>
          <p:nvPr/>
        </p:nvGrpSpPr>
        <p:grpSpPr bwMode="auto">
          <a:xfrm>
            <a:off x="179388" y="1989138"/>
            <a:ext cx="1439862" cy="2808287"/>
            <a:chOff x="295" y="1253"/>
            <a:chExt cx="907" cy="1769"/>
          </a:xfrm>
        </p:grpSpPr>
        <p:sp>
          <p:nvSpPr>
            <p:cNvPr id="13401" name="Line 50"/>
            <p:cNvSpPr>
              <a:spLocks noChangeShapeType="1"/>
            </p:cNvSpPr>
            <p:nvPr/>
          </p:nvSpPr>
          <p:spPr bwMode="auto">
            <a:xfrm>
              <a:off x="295" y="1480"/>
              <a:ext cx="68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02" name="Text Box 51"/>
            <p:cNvSpPr txBox="1">
              <a:spLocks noChangeArrowheads="1"/>
            </p:cNvSpPr>
            <p:nvPr/>
          </p:nvSpPr>
          <p:spPr bwMode="auto">
            <a:xfrm>
              <a:off x="794" y="1253"/>
              <a:ext cx="408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>
                  <a:latin typeface="Calibri" pitchFamily="34" charset="0"/>
                </a:rPr>
                <a:t>G</a:t>
              </a:r>
              <a:r>
                <a:rPr lang="en-GB" baseline="-25000">
                  <a:latin typeface="Calibri" pitchFamily="34" charset="0"/>
                </a:rPr>
                <a:t>P</a:t>
              </a:r>
              <a:endParaRPr lang="en-GB">
                <a:latin typeface="Calibri" pitchFamily="34" charset="0"/>
              </a:endParaRPr>
            </a:p>
          </p:txBody>
        </p:sp>
        <p:sp>
          <p:nvSpPr>
            <p:cNvPr id="13403" name="Line 52"/>
            <p:cNvSpPr>
              <a:spLocks noChangeShapeType="1"/>
            </p:cNvSpPr>
            <p:nvPr/>
          </p:nvSpPr>
          <p:spPr bwMode="auto">
            <a:xfrm>
              <a:off x="612" y="1480"/>
              <a:ext cx="0" cy="1542"/>
            </a:xfrm>
            <a:prstGeom prst="line">
              <a:avLst/>
            </a:prstGeom>
            <a:noFill/>
            <a:ln w="38100">
              <a:solidFill>
                <a:srgbClr val="C0C0C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404" name="Text Box 53"/>
            <p:cNvSpPr txBox="1">
              <a:spLocks noChangeArrowheads="1"/>
            </p:cNvSpPr>
            <p:nvPr/>
          </p:nvSpPr>
          <p:spPr bwMode="auto">
            <a:xfrm>
              <a:off x="476" y="1253"/>
              <a:ext cx="499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>
                  <a:solidFill>
                    <a:schemeClr val="bg2"/>
                  </a:solidFill>
                  <a:latin typeface="Calibri" pitchFamily="34" charset="0"/>
                </a:rPr>
                <a:t>B</a:t>
              </a:r>
              <a:r>
                <a:rPr lang="en-GB" baseline="-25000">
                  <a:solidFill>
                    <a:schemeClr val="bg2"/>
                  </a:solidFill>
                  <a:latin typeface="Calibri" pitchFamily="34" charset="0"/>
                </a:rPr>
                <a:t>o</a:t>
              </a:r>
              <a:endParaRPr lang="en-GB">
                <a:solidFill>
                  <a:schemeClr val="bg2"/>
                </a:solidFill>
                <a:latin typeface="Calibri" pitchFamily="34" charset="0"/>
              </a:endParaRPr>
            </a:p>
          </p:txBody>
        </p:sp>
      </p:grpSp>
      <p:grpSp>
        <p:nvGrpSpPr>
          <p:cNvPr id="13" name="Group 66"/>
          <p:cNvGrpSpPr>
            <a:grpSpLocks/>
          </p:cNvGrpSpPr>
          <p:nvPr/>
        </p:nvGrpSpPr>
        <p:grpSpPr bwMode="auto">
          <a:xfrm>
            <a:off x="1116013" y="5661025"/>
            <a:ext cx="3311525" cy="1152525"/>
            <a:chOff x="703" y="3022"/>
            <a:chExt cx="2086" cy="726"/>
          </a:xfrm>
        </p:grpSpPr>
        <p:sp>
          <p:nvSpPr>
            <p:cNvPr id="13397" name="Line 56"/>
            <p:cNvSpPr>
              <a:spLocks noChangeShapeType="1"/>
            </p:cNvSpPr>
            <p:nvPr/>
          </p:nvSpPr>
          <p:spPr bwMode="auto">
            <a:xfrm flipV="1">
              <a:off x="930" y="3113"/>
              <a:ext cx="0" cy="63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98" name="Text Box 62"/>
            <p:cNvSpPr txBox="1">
              <a:spLocks noChangeArrowheads="1"/>
            </p:cNvSpPr>
            <p:nvPr/>
          </p:nvSpPr>
          <p:spPr bwMode="auto">
            <a:xfrm>
              <a:off x="703" y="3022"/>
              <a:ext cx="317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>
                  <a:latin typeface="Calibri" pitchFamily="34" charset="0"/>
                </a:rPr>
                <a:t>G</a:t>
              </a:r>
              <a:r>
                <a:rPr lang="en-GB" baseline="-25000">
                  <a:latin typeface="Calibri" pitchFamily="34" charset="0"/>
                </a:rPr>
                <a:t>F</a:t>
              </a:r>
              <a:endParaRPr lang="en-GB">
                <a:latin typeface="Calibri" pitchFamily="34" charset="0"/>
              </a:endParaRPr>
            </a:p>
          </p:txBody>
        </p:sp>
        <p:sp>
          <p:nvSpPr>
            <p:cNvPr id="13399" name="Text Box 63"/>
            <p:cNvSpPr txBox="1">
              <a:spLocks noChangeArrowheads="1"/>
            </p:cNvSpPr>
            <p:nvPr/>
          </p:nvSpPr>
          <p:spPr bwMode="auto">
            <a:xfrm>
              <a:off x="703" y="3385"/>
              <a:ext cx="272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>
                  <a:solidFill>
                    <a:schemeClr val="bg2"/>
                  </a:solidFill>
                  <a:latin typeface="Calibri" pitchFamily="34" charset="0"/>
                </a:rPr>
                <a:t>B</a:t>
              </a:r>
              <a:r>
                <a:rPr lang="en-GB" baseline="-25000">
                  <a:solidFill>
                    <a:schemeClr val="bg2"/>
                  </a:solidFill>
                  <a:latin typeface="Calibri" pitchFamily="34" charset="0"/>
                </a:rPr>
                <a:t>o</a:t>
              </a:r>
              <a:endParaRPr lang="en-GB">
                <a:solidFill>
                  <a:schemeClr val="bg2"/>
                </a:solidFill>
                <a:latin typeface="Calibri" pitchFamily="34" charset="0"/>
              </a:endParaRPr>
            </a:p>
          </p:txBody>
        </p:sp>
        <p:sp>
          <p:nvSpPr>
            <p:cNvPr id="13400" name="Line 64"/>
            <p:cNvSpPr>
              <a:spLocks noChangeShapeType="1"/>
            </p:cNvSpPr>
            <p:nvPr/>
          </p:nvSpPr>
          <p:spPr bwMode="auto">
            <a:xfrm>
              <a:off x="930" y="3475"/>
              <a:ext cx="1859" cy="0"/>
            </a:xfrm>
            <a:prstGeom prst="line">
              <a:avLst/>
            </a:prstGeom>
            <a:noFill/>
            <a:ln w="38100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43073" name="Line 65"/>
          <p:cNvSpPr>
            <a:spLocks noChangeShapeType="1"/>
          </p:cNvSpPr>
          <p:nvPr/>
        </p:nvSpPr>
        <p:spPr bwMode="auto">
          <a:xfrm flipV="1">
            <a:off x="1619250" y="6021388"/>
            <a:ext cx="2736850" cy="720725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4" name="Group 67"/>
          <p:cNvGrpSpPr>
            <a:grpSpLocks/>
          </p:cNvGrpSpPr>
          <p:nvPr/>
        </p:nvGrpSpPr>
        <p:grpSpPr bwMode="auto">
          <a:xfrm rot="-3626252">
            <a:off x="1974850" y="2695576"/>
            <a:ext cx="280987" cy="595312"/>
            <a:chOff x="204" y="1728"/>
            <a:chExt cx="472" cy="931"/>
          </a:xfrm>
        </p:grpSpPr>
        <p:sp>
          <p:nvSpPr>
            <p:cNvPr id="43076" name="Oval 68"/>
            <p:cNvSpPr>
              <a:spLocks noChangeArrowheads="1"/>
            </p:cNvSpPr>
            <p:nvPr/>
          </p:nvSpPr>
          <p:spPr bwMode="auto">
            <a:xfrm rot="5350479" flipH="1">
              <a:off x="200" y="1953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95" name="Line 69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96" name="Line 70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71"/>
          <p:cNvGrpSpPr>
            <a:grpSpLocks/>
          </p:cNvGrpSpPr>
          <p:nvPr/>
        </p:nvGrpSpPr>
        <p:grpSpPr bwMode="auto">
          <a:xfrm rot="-3626252">
            <a:off x="2765425" y="2695576"/>
            <a:ext cx="280987" cy="595312"/>
            <a:chOff x="204" y="1728"/>
            <a:chExt cx="472" cy="931"/>
          </a:xfrm>
        </p:grpSpPr>
        <p:sp>
          <p:nvSpPr>
            <p:cNvPr id="43080" name="Oval 72"/>
            <p:cNvSpPr>
              <a:spLocks noChangeArrowheads="1"/>
            </p:cNvSpPr>
            <p:nvPr/>
          </p:nvSpPr>
          <p:spPr bwMode="auto">
            <a:xfrm rot="5350479" flipH="1">
              <a:off x="200" y="1953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92" name="Line 73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93" name="Line 74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6" name="Group 75"/>
          <p:cNvGrpSpPr>
            <a:grpSpLocks/>
          </p:cNvGrpSpPr>
          <p:nvPr/>
        </p:nvGrpSpPr>
        <p:grpSpPr bwMode="auto">
          <a:xfrm rot="-3626252">
            <a:off x="3557588" y="2695575"/>
            <a:ext cx="280987" cy="595313"/>
            <a:chOff x="204" y="1728"/>
            <a:chExt cx="472" cy="931"/>
          </a:xfrm>
        </p:grpSpPr>
        <p:sp>
          <p:nvSpPr>
            <p:cNvPr id="43084" name="Oval 76"/>
            <p:cNvSpPr>
              <a:spLocks noChangeArrowheads="1"/>
            </p:cNvSpPr>
            <p:nvPr/>
          </p:nvSpPr>
          <p:spPr bwMode="auto">
            <a:xfrm rot="5350479" flipH="1">
              <a:off x="200" y="1953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89" name="Line 77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90" name="Line 78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7" name="Group 79"/>
          <p:cNvGrpSpPr>
            <a:grpSpLocks/>
          </p:cNvGrpSpPr>
          <p:nvPr/>
        </p:nvGrpSpPr>
        <p:grpSpPr bwMode="auto">
          <a:xfrm rot="1773748">
            <a:off x="1978025" y="3352800"/>
            <a:ext cx="280988" cy="595313"/>
            <a:chOff x="204" y="1728"/>
            <a:chExt cx="472" cy="931"/>
          </a:xfrm>
        </p:grpSpPr>
        <p:sp>
          <p:nvSpPr>
            <p:cNvPr id="43088" name="Oval 80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86" name="Line 81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87" name="Line 82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8" name="Group 83"/>
          <p:cNvGrpSpPr>
            <a:grpSpLocks/>
          </p:cNvGrpSpPr>
          <p:nvPr/>
        </p:nvGrpSpPr>
        <p:grpSpPr bwMode="auto">
          <a:xfrm rot="1773748">
            <a:off x="2770188" y="3352800"/>
            <a:ext cx="280987" cy="595313"/>
            <a:chOff x="204" y="1728"/>
            <a:chExt cx="472" cy="931"/>
          </a:xfrm>
        </p:grpSpPr>
        <p:sp>
          <p:nvSpPr>
            <p:cNvPr id="43092" name="Oval 84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83" name="Line 85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84" name="Line 86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9" name="Group 87"/>
          <p:cNvGrpSpPr>
            <a:grpSpLocks/>
          </p:cNvGrpSpPr>
          <p:nvPr/>
        </p:nvGrpSpPr>
        <p:grpSpPr bwMode="auto">
          <a:xfrm rot="1773748">
            <a:off x="3567113" y="3352800"/>
            <a:ext cx="280987" cy="595313"/>
            <a:chOff x="204" y="1728"/>
            <a:chExt cx="472" cy="931"/>
          </a:xfrm>
        </p:grpSpPr>
        <p:sp>
          <p:nvSpPr>
            <p:cNvPr id="43096" name="Oval 88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80" name="Line 89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81" name="Line 90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0" name="Group 91"/>
          <p:cNvGrpSpPr>
            <a:grpSpLocks/>
          </p:cNvGrpSpPr>
          <p:nvPr/>
        </p:nvGrpSpPr>
        <p:grpSpPr bwMode="auto">
          <a:xfrm rot="7173748">
            <a:off x="1966913" y="3981450"/>
            <a:ext cx="280987" cy="595313"/>
            <a:chOff x="204" y="1728"/>
            <a:chExt cx="472" cy="931"/>
          </a:xfrm>
        </p:grpSpPr>
        <p:sp>
          <p:nvSpPr>
            <p:cNvPr id="43100" name="Oval 92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77" name="Line 93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8" name="Line 94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1" name="Group 95"/>
          <p:cNvGrpSpPr>
            <a:grpSpLocks/>
          </p:cNvGrpSpPr>
          <p:nvPr/>
        </p:nvGrpSpPr>
        <p:grpSpPr bwMode="auto">
          <a:xfrm rot="7173748">
            <a:off x="2757488" y="3981450"/>
            <a:ext cx="280987" cy="595313"/>
            <a:chOff x="204" y="1728"/>
            <a:chExt cx="472" cy="931"/>
          </a:xfrm>
        </p:grpSpPr>
        <p:sp>
          <p:nvSpPr>
            <p:cNvPr id="43104" name="Oval 96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74" name="Line 97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5" name="Line 98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2" name="Group 99"/>
          <p:cNvGrpSpPr>
            <a:grpSpLocks/>
          </p:cNvGrpSpPr>
          <p:nvPr/>
        </p:nvGrpSpPr>
        <p:grpSpPr bwMode="auto">
          <a:xfrm rot="7173748">
            <a:off x="3549650" y="3981451"/>
            <a:ext cx="280987" cy="595312"/>
            <a:chOff x="204" y="1728"/>
            <a:chExt cx="472" cy="931"/>
          </a:xfrm>
        </p:grpSpPr>
        <p:sp>
          <p:nvSpPr>
            <p:cNvPr id="43108" name="Oval 100"/>
            <p:cNvSpPr>
              <a:spLocks noChangeArrowheads="1"/>
            </p:cNvSpPr>
            <p:nvPr/>
          </p:nvSpPr>
          <p:spPr bwMode="auto">
            <a:xfrm rot="5350479" flipH="1">
              <a:off x="197" y="1954"/>
              <a:ext cx="482" cy="472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gamma/>
                    <a:shade val="46275"/>
                    <a:invGamma/>
                  </a:schemeClr>
                </a:gs>
                <a:gs pos="100000">
                  <a:schemeClr val="accent1"/>
                </a:gs>
              </a:gsLst>
              <a:lin ang="2700000" scaled="1"/>
            </a:gra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>
                <a:latin typeface="+mn-lt"/>
              </a:endParaRPr>
            </a:p>
          </p:txBody>
        </p:sp>
        <p:sp>
          <p:nvSpPr>
            <p:cNvPr id="13371" name="Line 101"/>
            <p:cNvSpPr>
              <a:spLocks noChangeShapeType="1"/>
            </p:cNvSpPr>
            <p:nvPr/>
          </p:nvSpPr>
          <p:spPr bwMode="auto">
            <a:xfrm rot="7675445" flipH="1">
              <a:off x="297" y="1759"/>
              <a:ext cx="285" cy="223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2" name="Line 102"/>
            <p:cNvSpPr>
              <a:spLocks noChangeShapeType="1"/>
            </p:cNvSpPr>
            <p:nvPr/>
          </p:nvSpPr>
          <p:spPr bwMode="auto">
            <a:xfrm rot="7675445" flipH="1">
              <a:off x="340" y="2480"/>
              <a:ext cx="200" cy="157"/>
            </a:xfrm>
            <a:prstGeom prst="line">
              <a:avLst/>
            </a:prstGeom>
            <a:noFill/>
            <a:ln w="635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43115" name="Text Box 107"/>
          <p:cNvSpPr txBox="1">
            <a:spLocks noChangeArrowheads="1"/>
          </p:cNvSpPr>
          <p:nvPr/>
        </p:nvSpPr>
        <p:spPr bwMode="auto">
          <a:xfrm>
            <a:off x="4916488" y="5014913"/>
            <a:ext cx="863600" cy="1006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sz="6000">
                <a:latin typeface="Calibri" pitchFamily="34" charset="0"/>
                <a:cs typeface="Arial" charset="0"/>
              </a:rPr>
              <a:t>Σ</a:t>
            </a:r>
          </a:p>
        </p:txBody>
      </p:sp>
      <p:grpSp>
        <p:nvGrpSpPr>
          <p:cNvPr id="13343" name="Group 138"/>
          <p:cNvGrpSpPr>
            <a:grpSpLocks/>
          </p:cNvGrpSpPr>
          <p:nvPr/>
        </p:nvGrpSpPr>
        <p:grpSpPr bwMode="auto">
          <a:xfrm>
            <a:off x="0" y="4941888"/>
            <a:ext cx="1258888" cy="1144587"/>
            <a:chOff x="22" y="2830"/>
            <a:chExt cx="1089" cy="1066"/>
          </a:xfrm>
        </p:grpSpPr>
        <p:sp>
          <p:nvSpPr>
            <p:cNvPr id="13366" name="Line 139"/>
            <p:cNvSpPr>
              <a:spLocks noChangeShapeType="1"/>
            </p:cNvSpPr>
            <p:nvPr/>
          </p:nvSpPr>
          <p:spPr bwMode="auto">
            <a:xfrm flipV="1">
              <a:off x="204" y="2840"/>
              <a:ext cx="0" cy="7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7" name="Line 140"/>
            <p:cNvSpPr>
              <a:spLocks noChangeShapeType="1"/>
            </p:cNvSpPr>
            <p:nvPr/>
          </p:nvSpPr>
          <p:spPr bwMode="auto">
            <a:xfrm>
              <a:off x="204" y="3566"/>
              <a:ext cx="72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8" name="Text Box 141"/>
            <p:cNvSpPr txBox="1">
              <a:spLocks noChangeArrowheads="1"/>
            </p:cNvSpPr>
            <p:nvPr/>
          </p:nvSpPr>
          <p:spPr bwMode="auto">
            <a:xfrm>
              <a:off x="794" y="3612"/>
              <a:ext cx="317" cy="2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 sz="1400">
                  <a:latin typeface="Calibri" pitchFamily="34" charset="0"/>
                </a:rPr>
                <a:t>x</a:t>
              </a:r>
            </a:p>
          </p:txBody>
        </p:sp>
        <p:sp>
          <p:nvSpPr>
            <p:cNvPr id="13369" name="Text Box 142"/>
            <p:cNvSpPr txBox="1">
              <a:spLocks noChangeArrowheads="1"/>
            </p:cNvSpPr>
            <p:nvPr/>
          </p:nvSpPr>
          <p:spPr bwMode="auto">
            <a:xfrm>
              <a:off x="22" y="2830"/>
              <a:ext cx="317" cy="2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 sz="1400">
                  <a:latin typeface="Calibri" pitchFamily="34" charset="0"/>
                </a:rPr>
                <a:t>y</a:t>
              </a:r>
            </a:p>
          </p:txBody>
        </p:sp>
      </p:grpSp>
      <p:sp>
        <p:nvSpPr>
          <p:cNvPr id="129" name="TextBox 128"/>
          <p:cNvSpPr txBox="1"/>
          <p:nvPr/>
        </p:nvSpPr>
        <p:spPr>
          <a:xfrm>
            <a:off x="395288" y="260350"/>
            <a:ext cx="8208962" cy="76993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4400" dirty="0">
                <a:latin typeface="+mn-lt"/>
              </a:rPr>
              <a:t>Step2 : Phase Encoding</a:t>
            </a:r>
            <a:endParaRPr lang="en-GB" sz="4400" dirty="0">
              <a:latin typeface="+mn-lt"/>
            </a:endParaRPr>
          </a:p>
        </p:txBody>
      </p:sp>
      <p:sp>
        <p:nvSpPr>
          <p:cNvPr id="130" name="Freeform 129"/>
          <p:cNvSpPr/>
          <p:nvPr/>
        </p:nvSpPr>
        <p:spPr>
          <a:xfrm>
            <a:off x="1763713" y="5041900"/>
            <a:ext cx="488950" cy="908050"/>
          </a:xfrm>
          <a:custGeom>
            <a:avLst/>
            <a:gdLst>
              <a:gd name="connsiteX0" fmla="*/ 278167 w 488271"/>
              <a:gd name="connsiteY0" fmla="*/ 0 h 656947"/>
              <a:gd name="connsiteX1" fmla="*/ 29592 w 488271"/>
              <a:gd name="connsiteY1" fmla="*/ 177553 h 656947"/>
              <a:gd name="connsiteX2" fmla="*/ 455720 w 488271"/>
              <a:gd name="connsiteY2" fmla="*/ 435005 h 656947"/>
              <a:gd name="connsiteX3" fmla="*/ 224901 w 488271"/>
              <a:gd name="connsiteY3" fmla="*/ 656947 h 6569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88271" h="656947">
                <a:moveTo>
                  <a:pt x="278167" y="0"/>
                </a:moveTo>
                <a:cubicBezTo>
                  <a:pt x="139083" y="52526"/>
                  <a:pt x="0" y="105052"/>
                  <a:pt x="29592" y="177553"/>
                </a:cubicBezTo>
                <a:cubicBezTo>
                  <a:pt x="59184" y="250054"/>
                  <a:pt x="423169" y="355106"/>
                  <a:pt x="455720" y="435005"/>
                </a:cubicBezTo>
                <a:cubicBezTo>
                  <a:pt x="488271" y="514904"/>
                  <a:pt x="356586" y="585925"/>
                  <a:pt x="224901" y="656947"/>
                </a:cubicBezTo>
              </a:path>
            </a:pathLst>
          </a:cu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139" name="Freeform 138"/>
          <p:cNvSpPr/>
          <p:nvPr/>
        </p:nvSpPr>
        <p:spPr>
          <a:xfrm>
            <a:off x="2643188" y="5048250"/>
            <a:ext cx="401637" cy="901700"/>
          </a:xfrm>
          <a:custGeom>
            <a:avLst/>
            <a:gdLst>
              <a:gd name="connsiteX0" fmla="*/ 87297 w 400974"/>
              <a:gd name="connsiteY0" fmla="*/ 0 h 1091954"/>
              <a:gd name="connsiteX1" fmla="*/ 51786 w 400974"/>
              <a:gd name="connsiteY1" fmla="*/ 53266 h 1091954"/>
              <a:gd name="connsiteX2" fmla="*/ 398015 w 400974"/>
              <a:gd name="connsiteY2" fmla="*/ 204187 h 1091954"/>
              <a:gd name="connsiteX3" fmla="*/ 34031 w 400974"/>
              <a:gd name="connsiteY3" fmla="*/ 328474 h 1091954"/>
              <a:gd name="connsiteX4" fmla="*/ 389138 w 400974"/>
              <a:gd name="connsiteY4" fmla="*/ 461639 h 1091954"/>
              <a:gd name="connsiteX5" fmla="*/ 34031 w 400974"/>
              <a:gd name="connsiteY5" fmla="*/ 639192 h 1091954"/>
              <a:gd name="connsiteX6" fmla="*/ 371382 w 400974"/>
              <a:gd name="connsiteY6" fmla="*/ 736847 h 1091954"/>
              <a:gd name="connsiteX7" fmla="*/ 34031 w 400974"/>
              <a:gd name="connsiteY7" fmla="*/ 861134 h 1091954"/>
              <a:gd name="connsiteX8" fmla="*/ 389138 w 400974"/>
              <a:gd name="connsiteY8" fmla="*/ 1012055 h 1091954"/>
              <a:gd name="connsiteX9" fmla="*/ 78419 w 400974"/>
              <a:gd name="connsiteY9" fmla="*/ 1091954 h 10919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400974" h="1091954">
                <a:moveTo>
                  <a:pt x="87297" y="0"/>
                </a:moveTo>
                <a:cubicBezTo>
                  <a:pt x="43648" y="9617"/>
                  <a:pt x="0" y="19235"/>
                  <a:pt x="51786" y="53266"/>
                </a:cubicBezTo>
                <a:cubicBezTo>
                  <a:pt x="103572" y="87297"/>
                  <a:pt x="400974" y="158319"/>
                  <a:pt x="398015" y="204187"/>
                </a:cubicBezTo>
                <a:cubicBezTo>
                  <a:pt x="395056" y="250055"/>
                  <a:pt x="35510" y="285565"/>
                  <a:pt x="34031" y="328474"/>
                </a:cubicBezTo>
                <a:cubicBezTo>
                  <a:pt x="32552" y="371383"/>
                  <a:pt x="389138" y="409853"/>
                  <a:pt x="389138" y="461639"/>
                </a:cubicBezTo>
                <a:cubicBezTo>
                  <a:pt x="389138" y="513425"/>
                  <a:pt x="36990" y="593324"/>
                  <a:pt x="34031" y="639192"/>
                </a:cubicBezTo>
                <a:cubicBezTo>
                  <a:pt x="31072" y="685060"/>
                  <a:pt x="371382" y="699857"/>
                  <a:pt x="371382" y="736847"/>
                </a:cubicBezTo>
                <a:cubicBezTo>
                  <a:pt x="371382" y="773837"/>
                  <a:pt x="31072" y="815266"/>
                  <a:pt x="34031" y="861134"/>
                </a:cubicBezTo>
                <a:cubicBezTo>
                  <a:pt x="36990" y="907002"/>
                  <a:pt x="381740" y="973585"/>
                  <a:pt x="389138" y="1012055"/>
                </a:cubicBezTo>
                <a:cubicBezTo>
                  <a:pt x="396536" y="1050525"/>
                  <a:pt x="237477" y="1071239"/>
                  <a:pt x="78419" y="1091954"/>
                </a:cubicBezTo>
              </a:path>
            </a:pathLst>
          </a:cu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grpSp>
        <p:nvGrpSpPr>
          <p:cNvPr id="145" name="Group 144"/>
          <p:cNvGrpSpPr/>
          <p:nvPr/>
        </p:nvGrpSpPr>
        <p:grpSpPr>
          <a:xfrm>
            <a:off x="3404087" y="5022054"/>
            <a:ext cx="628341" cy="936104"/>
            <a:chOff x="3491880" y="4509120"/>
            <a:chExt cx="628341" cy="2304256"/>
          </a:xfrm>
          <a:scene3d>
            <a:camera prst="orthographicFront">
              <a:rot lat="0" lon="0" rev="420000"/>
            </a:camera>
            <a:lightRig rig="threePt" dir="t"/>
          </a:scene3d>
        </p:grpSpPr>
        <p:sp>
          <p:nvSpPr>
            <p:cNvPr id="141" name="Freeform 140"/>
            <p:cNvSpPr/>
            <p:nvPr/>
          </p:nvSpPr>
          <p:spPr>
            <a:xfrm>
              <a:off x="3522956" y="5078027"/>
              <a:ext cx="556333" cy="583221"/>
            </a:xfrm>
            <a:custGeom>
              <a:avLst/>
              <a:gdLst>
                <a:gd name="connsiteX0" fmla="*/ 125766 w 556333"/>
                <a:gd name="connsiteY0" fmla="*/ 0 h 1083076"/>
                <a:gd name="connsiteX1" fmla="*/ 543017 w 556333"/>
                <a:gd name="connsiteY1" fmla="*/ 301841 h 1083076"/>
                <a:gd name="connsiteX2" fmla="*/ 45867 w 556333"/>
                <a:gd name="connsiteY2" fmla="*/ 514905 h 1083076"/>
                <a:gd name="connsiteX3" fmla="*/ 525261 w 556333"/>
                <a:gd name="connsiteY3" fmla="*/ 727969 h 1083076"/>
                <a:gd name="connsiteX4" fmla="*/ 63623 w 556333"/>
                <a:gd name="connsiteY4" fmla="*/ 967666 h 1083076"/>
                <a:gd name="connsiteX5" fmla="*/ 143522 w 556333"/>
                <a:gd name="connsiteY5" fmla="*/ 1083076 h 10830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56333" h="1083076">
                  <a:moveTo>
                    <a:pt x="125766" y="0"/>
                  </a:moveTo>
                  <a:cubicBezTo>
                    <a:pt x="341049" y="108012"/>
                    <a:pt x="556333" y="216024"/>
                    <a:pt x="543017" y="301841"/>
                  </a:cubicBezTo>
                  <a:cubicBezTo>
                    <a:pt x="529701" y="387658"/>
                    <a:pt x="48826" y="443884"/>
                    <a:pt x="45867" y="514905"/>
                  </a:cubicBezTo>
                  <a:cubicBezTo>
                    <a:pt x="42908" y="585926"/>
                    <a:pt x="522302" y="652509"/>
                    <a:pt x="525261" y="727969"/>
                  </a:cubicBezTo>
                  <a:cubicBezTo>
                    <a:pt x="528220" y="803429"/>
                    <a:pt x="127246" y="908482"/>
                    <a:pt x="63623" y="967666"/>
                  </a:cubicBezTo>
                  <a:cubicBezTo>
                    <a:pt x="0" y="1026851"/>
                    <a:pt x="71761" y="1054963"/>
                    <a:pt x="143522" y="1083076"/>
                  </a:cubicBezTo>
                </a:path>
              </a:pathLst>
            </a:cu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142" name="Freeform 141"/>
            <p:cNvSpPr/>
            <p:nvPr/>
          </p:nvSpPr>
          <p:spPr>
            <a:xfrm>
              <a:off x="3491880" y="5652370"/>
              <a:ext cx="556333" cy="583221"/>
            </a:xfrm>
            <a:custGeom>
              <a:avLst/>
              <a:gdLst>
                <a:gd name="connsiteX0" fmla="*/ 125766 w 556333"/>
                <a:gd name="connsiteY0" fmla="*/ 0 h 1083076"/>
                <a:gd name="connsiteX1" fmla="*/ 543017 w 556333"/>
                <a:gd name="connsiteY1" fmla="*/ 301841 h 1083076"/>
                <a:gd name="connsiteX2" fmla="*/ 45867 w 556333"/>
                <a:gd name="connsiteY2" fmla="*/ 514905 h 1083076"/>
                <a:gd name="connsiteX3" fmla="*/ 525261 w 556333"/>
                <a:gd name="connsiteY3" fmla="*/ 727969 h 1083076"/>
                <a:gd name="connsiteX4" fmla="*/ 63623 w 556333"/>
                <a:gd name="connsiteY4" fmla="*/ 967666 h 1083076"/>
                <a:gd name="connsiteX5" fmla="*/ 143522 w 556333"/>
                <a:gd name="connsiteY5" fmla="*/ 1083076 h 10830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56333" h="1083076">
                  <a:moveTo>
                    <a:pt x="125766" y="0"/>
                  </a:moveTo>
                  <a:cubicBezTo>
                    <a:pt x="341049" y="108012"/>
                    <a:pt x="556333" y="216024"/>
                    <a:pt x="543017" y="301841"/>
                  </a:cubicBezTo>
                  <a:cubicBezTo>
                    <a:pt x="529701" y="387658"/>
                    <a:pt x="48826" y="443884"/>
                    <a:pt x="45867" y="514905"/>
                  </a:cubicBezTo>
                  <a:cubicBezTo>
                    <a:pt x="42908" y="585926"/>
                    <a:pt x="522302" y="652509"/>
                    <a:pt x="525261" y="727969"/>
                  </a:cubicBezTo>
                  <a:cubicBezTo>
                    <a:pt x="528220" y="803429"/>
                    <a:pt x="127246" y="908482"/>
                    <a:pt x="63623" y="967666"/>
                  </a:cubicBezTo>
                  <a:cubicBezTo>
                    <a:pt x="0" y="1026851"/>
                    <a:pt x="71761" y="1054963"/>
                    <a:pt x="143522" y="1083076"/>
                  </a:cubicBezTo>
                </a:path>
              </a:pathLst>
            </a:cu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143" name="Freeform 142"/>
            <p:cNvSpPr/>
            <p:nvPr/>
          </p:nvSpPr>
          <p:spPr>
            <a:xfrm>
              <a:off x="3491880" y="6230155"/>
              <a:ext cx="556333" cy="583221"/>
            </a:xfrm>
            <a:custGeom>
              <a:avLst/>
              <a:gdLst>
                <a:gd name="connsiteX0" fmla="*/ 125766 w 556333"/>
                <a:gd name="connsiteY0" fmla="*/ 0 h 1083076"/>
                <a:gd name="connsiteX1" fmla="*/ 543017 w 556333"/>
                <a:gd name="connsiteY1" fmla="*/ 301841 h 1083076"/>
                <a:gd name="connsiteX2" fmla="*/ 45867 w 556333"/>
                <a:gd name="connsiteY2" fmla="*/ 514905 h 1083076"/>
                <a:gd name="connsiteX3" fmla="*/ 525261 w 556333"/>
                <a:gd name="connsiteY3" fmla="*/ 727969 h 1083076"/>
                <a:gd name="connsiteX4" fmla="*/ 63623 w 556333"/>
                <a:gd name="connsiteY4" fmla="*/ 967666 h 1083076"/>
                <a:gd name="connsiteX5" fmla="*/ 143522 w 556333"/>
                <a:gd name="connsiteY5" fmla="*/ 1083076 h 10830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56333" h="1083076">
                  <a:moveTo>
                    <a:pt x="125766" y="0"/>
                  </a:moveTo>
                  <a:cubicBezTo>
                    <a:pt x="341049" y="108012"/>
                    <a:pt x="556333" y="216024"/>
                    <a:pt x="543017" y="301841"/>
                  </a:cubicBezTo>
                  <a:cubicBezTo>
                    <a:pt x="529701" y="387658"/>
                    <a:pt x="48826" y="443884"/>
                    <a:pt x="45867" y="514905"/>
                  </a:cubicBezTo>
                  <a:cubicBezTo>
                    <a:pt x="42908" y="585926"/>
                    <a:pt x="522302" y="652509"/>
                    <a:pt x="525261" y="727969"/>
                  </a:cubicBezTo>
                  <a:cubicBezTo>
                    <a:pt x="528220" y="803429"/>
                    <a:pt x="127246" y="908482"/>
                    <a:pt x="63623" y="967666"/>
                  </a:cubicBezTo>
                  <a:cubicBezTo>
                    <a:pt x="0" y="1026851"/>
                    <a:pt x="71761" y="1054963"/>
                    <a:pt x="143522" y="1083076"/>
                  </a:cubicBezTo>
                </a:path>
              </a:pathLst>
            </a:cu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144" name="Freeform 143"/>
            <p:cNvSpPr/>
            <p:nvPr/>
          </p:nvSpPr>
          <p:spPr>
            <a:xfrm>
              <a:off x="3563888" y="4509120"/>
              <a:ext cx="556333" cy="583221"/>
            </a:xfrm>
            <a:custGeom>
              <a:avLst/>
              <a:gdLst>
                <a:gd name="connsiteX0" fmla="*/ 125766 w 556333"/>
                <a:gd name="connsiteY0" fmla="*/ 0 h 1083076"/>
                <a:gd name="connsiteX1" fmla="*/ 543017 w 556333"/>
                <a:gd name="connsiteY1" fmla="*/ 301841 h 1083076"/>
                <a:gd name="connsiteX2" fmla="*/ 45867 w 556333"/>
                <a:gd name="connsiteY2" fmla="*/ 514905 h 1083076"/>
                <a:gd name="connsiteX3" fmla="*/ 525261 w 556333"/>
                <a:gd name="connsiteY3" fmla="*/ 727969 h 1083076"/>
                <a:gd name="connsiteX4" fmla="*/ 63623 w 556333"/>
                <a:gd name="connsiteY4" fmla="*/ 967666 h 1083076"/>
                <a:gd name="connsiteX5" fmla="*/ 143522 w 556333"/>
                <a:gd name="connsiteY5" fmla="*/ 1083076 h 10830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56333" h="1083076">
                  <a:moveTo>
                    <a:pt x="125766" y="0"/>
                  </a:moveTo>
                  <a:cubicBezTo>
                    <a:pt x="341049" y="108012"/>
                    <a:pt x="556333" y="216024"/>
                    <a:pt x="543017" y="301841"/>
                  </a:cubicBezTo>
                  <a:cubicBezTo>
                    <a:pt x="529701" y="387658"/>
                    <a:pt x="48826" y="443884"/>
                    <a:pt x="45867" y="514905"/>
                  </a:cubicBezTo>
                  <a:cubicBezTo>
                    <a:pt x="42908" y="585926"/>
                    <a:pt x="522302" y="652509"/>
                    <a:pt x="525261" y="727969"/>
                  </a:cubicBezTo>
                  <a:cubicBezTo>
                    <a:pt x="528220" y="803429"/>
                    <a:pt x="127246" y="908482"/>
                    <a:pt x="63623" y="967666"/>
                  </a:cubicBezTo>
                  <a:cubicBezTo>
                    <a:pt x="0" y="1026851"/>
                    <a:pt x="71761" y="1054963"/>
                    <a:pt x="143522" y="1083076"/>
                  </a:cubicBezTo>
                </a:path>
              </a:pathLst>
            </a:cu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</p:grpSp>
      <p:grpSp>
        <p:nvGrpSpPr>
          <p:cNvPr id="122" name="Group 121"/>
          <p:cNvGrpSpPr>
            <a:grpSpLocks/>
          </p:cNvGrpSpPr>
          <p:nvPr/>
        </p:nvGrpSpPr>
        <p:grpSpPr bwMode="auto">
          <a:xfrm>
            <a:off x="4787900" y="1557338"/>
            <a:ext cx="1296988" cy="3536950"/>
            <a:chOff x="4788024" y="1556792"/>
            <a:chExt cx="1296144" cy="3537103"/>
          </a:xfrm>
        </p:grpSpPr>
        <p:cxnSp>
          <p:nvCxnSpPr>
            <p:cNvPr id="147" name="Straight Arrow Connector 146"/>
            <p:cNvCxnSpPr/>
            <p:nvPr/>
          </p:nvCxnSpPr>
          <p:spPr>
            <a:xfrm rot="5400000" flipH="1" flipV="1">
              <a:off x="4681307" y="2672853"/>
              <a:ext cx="1224015" cy="1587"/>
            </a:xfrm>
            <a:prstGeom prst="straightConnector1">
              <a:avLst/>
            </a:prstGeom>
            <a:ln w="635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63" name="TextBox 147"/>
            <p:cNvSpPr txBox="1">
              <a:spLocks noChangeArrowheads="1"/>
            </p:cNvSpPr>
            <p:nvPr/>
          </p:nvSpPr>
          <p:spPr bwMode="auto">
            <a:xfrm>
              <a:off x="4860032" y="4509120"/>
              <a:ext cx="1224136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600">
                  <a:latin typeface="Calibri" pitchFamily="34" charset="0"/>
                </a:rPr>
                <a:t>Increasing phase</a:t>
              </a:r>
            </a:p>
          </p:txBody>
        </p:sp>
        <p:cxnSp>
          <p:nvCxnSpPr>
            <p:cNvPr id="149" name="Straight Arrow Connector 148"/>
            <p:cNvCxnSpPr/>
            <p:nvPr/>
          </p:nvCxnSpPr>
          <p:spPr>
            <a:xfrm rot="16200000" flipH="1">
              <a:off x="4681307" y="4012761"/>
              <a:ext cx="1224015" cy="1587"/>
            </a:xfrm>
            <a:prstGeom prst="straightConnector1">
              <a:avLst/>
            </a:prstGeom>
            <a:ln w="635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65" name="TextBox 149"/>
            <p:cNvSpPr txBox="1">
              <a:spLocks noChangeArrowheads="1"/>
            </p:cNvSpPr>
            <p:nvPr/>
          </p:nvSpPr>
          <p:spPr bwMode="auto">
            <a:xfrm>
              <a:off x="4788024" y="1556792"/>
              <a:ext cx="1224136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600">
                  <a:latin typeface="Calibri" pitchFamily="34" charset="0"/>
                </a:rPr>
                <a:t>Decreasing phase</a:t>
              </a:r>
            </a:p>
          </p:txBody>
        </p:sp>
      </p:grpSp>
      <p:sp>
        <p:nvSpPr>
          <p:cNvPr id="114" name="TextBox 113"/>
          <p:cNvSpPr txBox="1"/>
          <p:nvPr/>
        </p:nvSpPr>
        <p:spPr>
          <a:xfrm>
            <a:off x="5795963" y="2276475"/>
            <a:ext cx="3097212" cy="1939925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latin typeface="+mn-lt"/>
              </a:rPr>
              <a:t>Initially all the protons </a:t>
            </a:r>
            <a:r>
              <a:rPr lang="en-GB" dirty="0" err="1">
                <a:latin typeface="+mn-lt"/>
              </a:rPr>
              <a:t>precess</a:t>
            </a:r>
            <a:r>
              <a:rPr lang="en-GB" dirty="0">
                <a:latin typeface="+mn-lt"/>
              </a:rPr>
              <a:t> in phase with the same frequency, dependent on B</a:t>
            </a:r>
            <a:r>
              <a:rPr lang="en-GB" baseline="-25000" dirty="0">
                <a:latin typeface="+mn-lt"/>
              </a:rPr>
              <a:t>o.</a:t>
            </a: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5795963" y="2276475"/>
            <a:ext cx="3097212" cy="1846263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latin typeface="+mn-lt"/>
              </a:rPr>
              <a:t>The phase encoding gradient causes the spins to </a:t>
            </a:r>
            <a:r>
              <a:rPr lang="en-GB" dirty="0" err="1">
                <a:latin typeface="+mn-lt"/>
              </a:rPr>
              <a:t>precess</a:t>
            </a:r>
            <a:r>
              <a:rPr lang="en-GB" dirty="0">
                <a:latin typeface="+mn-lt"/>
              </a:rPr>
              <a:t> at different frequencies for a short time.</a:t>
            </a: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795963" y="2276475"/>
            <a:ext cx="3097212" cy="1939925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latin typeface="+mn-lt"/>
              </a:rPr>
              <a:t>When the phase encoding gradient is turned off the protons </a:t>
            </a:r>
            <a:r>
              <a:rPr lang="en-GB" dirty="0" err="1">
                <a:latin typeface="+mn-lt"/>
              </a:rPr>
              <a:t>precess</a:t>
            </a:r>
            <a:r>
              <a:rPr lang="en-GB" dirty="0">
                <a:latin typeface="+mn-lt"/>
              </a:rPr>
              <a:t> with the same frequency but different phase offsets.</a:t>
            </a: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5795963" y="2276475"/>
            <a:ext cx="3097212" cy="175418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latin typeface="+mn-lt"/>
              </a:rPr>
              <a:t>The frequency encoding gradient, is then applied in the x-direction</a:t>
            </a: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5795963" y="2276475"/>
            <a:ext cx="3097212" cy="203200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latin typeface="+mn-lt"/>
              </a:rPr>
              <a:t>The frequency encoding gradient causes the protons to </a:t>
            </a:r>
            <a:r>
              <a:rPr lang="en-GB" dirty="0" err="1">
                <a:latin typeface="+mn-lt"/>
              </a:rPr>
              <a:t>precess</a:t>
            </a:r>
            <a:r>
              <a:rPr lang="en-GB" dirty="0">
                <a:latin typeface="+mn-lt"/>
              </a:rPr>
              <a:t> with different frequencies along the x-direction whilst the signal is read out.</a:t>
            </a: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5795963" y="2276475"/>
            <a:ext cx="3097212" cy="1939925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latin typeface="+mn-lt"/>
              </a:rPr>
              <a:t>The actual measured signal is the sum of the signals from all of the protons.</a:t>
            </a: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baseline="-25000" dirty="0">
              <a:latin typeface="+mn-lt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latin typeface="+mn-lt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395288" y="260350"/>
            <a:ext cx="8208962" cy="76993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4400" dirty="0">
                <a:latin typeface="+mn-lt"/>
              </a:rPr>
              <a:t>Step3 : Frequency Encoding</a:t>
            </a:r>
            <a:endParaRPr lang="en-GB" sz="4400" dirty="0">
              <a:latin typeface="+mn-lt"/>
            </a:endParaRPr>
          </a:p>
        </p:txBody>
      </p:sp>
      <p:grpSp>
        <p:nvGrpSpPr>
          <p:cNvPr id="127" name="Group 126"/>
          <p:cNvGrpSpPr>
            <a:grpSpLocks/>
          </p:cNvGrpSpPr>
          <p:nvPr/>
        </p:nvGrpSpPr>
        <p:grpSpPr bwMode="auto">
          <a:xfrm>
            <a:off x="611188" y="1196975"/>
            <a:ext cx="4845050" cy="584200"/>
            <a:chOff x="1115616" y="1340768"/>
            <a:chExt cx="4844260" cy="584775"/>
          </a:xfrm>
        </p:grpSpPr>
        <p:cxnSp>
          <p:nvCxnSpPr>
            <p:cNvPr id="123" name="Straight Arrow Connector 122"/>
            <p:cNvCxnSpPr/>
            <p:nvPr/>
          </p:nvCxnSpPr>
          <p:spPr>
            <a:xfrm flipH="1" flipV="1">
              <a:off x="2123514" y="1772993"/>
              <a:ext cx="1223763" cy="1590"/>
            </a:xfrm>
            <a:prstGeom prst="straightConnector1">
              <a:avLst/>
            </a:prstGeom>
            <a:ln w="635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59" name="TextBox 123"/>
            <p:cNvSpPr txBox="1">
              <a:spLocks noChangeArrowheads="1"/>
            </p:cNvSpPr>
            <p:nvPr/>
          </p:nvSpPr>
          <p:spPr bwMode="auto">
            <a:xfrm>
              <a:off x="4735740" y="1340768"/>
              <a:ext cx="1224136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600">
                  <a:latin typeface="Calibri" pitchFamily="34" charset="0"/>
                </a:rPr>
                <a:t>Increasing frequency</a:t>
              </a:r>
            </a:p>
          </p:txBody>
        </p:sp>
        <p:cxnSp>
          <p:nvCxnSpPr>
            <p:cNvPr id="125" name="Straight Arrow Connector 124"/>
            <p:cNvCxnSpPr/>
            <p:nvPr/>
          </p:nvCxnSpPr>
          <p:spPr>
            <a:xfrm rot="10800000" flipH="1">
              <a:off x="3563142" y="1772993"/>
              <a:ext cx="1225350" cy="1590"/>
            </a:xfrm>
            <a:prstGeom prst="straightConnector1">
              <a:avLst/>
            </a:prstGeom>
            <a:ln w="635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61" name="TextBox 125"/>
            <p:cNvSpPr txBox="1">
              <a:spLocks noChangeArrowheads="1"/>
            </p:cNvSpPr>
            <p:nvPr/>
          </p:nvSpPr>
          <p:spPr bwMode="auto">
            <a:xfrm>
              <a:off x="1115616" y="1340768"/>
              <a:ext cx="1224136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600">
                  <a:latin typeface="Calibri" pitchFamily="34" charset="0"/>
                </a:rPr>
                <a:t>Decreasing frequency</a:t>
              </a:r>
            </a:p>
          </p:txBody>
        </p:sp>
      </p:grpSp>
      <p:sp>
        <p:nvSpPr>
          <p:cNvPr id="128" name="Freeform 127"/>
          <p:cNvSpPr/>
          <p:nvPr/>
        </p:nvSpPr>
        <p:spPr>
          <a:xfrm rot="16200000">
            <a:off x="6011070" y="5012531"/>
            <a:ext cx="1223962" cy="1050925"/>
          </a:xfrm>
          <a:custGeom>
            <a:avLst/>
            <a:gdLst>
              <a:gd name="connsiteX0" fmla="*/ 0 w 2432481"/>
              <a:gd name="connsiteY0" fmla="*/ 1935331 h 3262542"/>
              <a:gd name="connsiteX1" fmla="*/ 79899 w 2432481"/>
              <a:gd name="connsiteY1" fmla="*/ 2024108 h 3262542"/>
              <a:gd name="connsiteX2" fmla="*/ 97654 w 2432481"/>
              <a:gd name="connsiteY2" fmla="*/ 1704512 h 3262542"/>
              <a:gd name="connsiteX3" fmla="*/ 204186 w 2432481"/>
              <a:gd name="connsiteY3" fmla="*/ 1988597 h 3262542"/>
              <a:gd name="connsiteX4" fmla="*/ 275207 w 2432481"/>
              <a:gd name="connsiteY4" fmla="*/ 1606857 h 3262542"/>
              <a:gd name="connsiteX5" fmla="*/ 399495 w 2432481"/>
              <a:gd name="connsiteY5" fmla="*/ 2352582 h 3262542"/>
              <a:gd name="connsiteX6" fmla="*/ 559293 w 2432481"/>
              <a:gd name="connsiteY6" fmla="*/ 985420 h 3262542"/>
              <a:gd name="connsiteX7" fmla="*/ 656947 w 2432481"/>
              <a:gd name="connsiteY7" fmla="*/ 2041863 h 3262542"/>
              <a:gd name="connsiteX8" fmla="*/ 878889 w 2432481"/>
              <a:gd name="connsiteY8" fmla="*/ 168675 h 3262542"/>
              <a:gd name="connsiteX9" fmla="*/ 1065320 w 2432481"/>
              <a:gd name="connsiteY9" fmla="*/ 3053917 h 3262542"/>
              <a:gd name="connsiteX10" fmla="*/ 1233996 w 2432481"/>
              <a:gd name="connsiteY10" fmla="*/ 1420426 h 3262542"/>
              <a:gd name="connsiteX11" fmla="*/ 1340528 w 2432481"/>
              <a:gd name="connsiteY11" fmla="*/ 2201661 h 3262542"/>
              <a:gd name="connsiteX12" fmla="*/ 1438182 w 2432481"/>
              <a:gd name="connsiteY12" fmla="*/ 1811044 h 3262542"/>
              <a:gd name="connsiteX13" fmla="*/ 1580225 w 2432481"/>
              <a:gd name="connsiteY13" fmla="*/ 2556768 h 3262542"/>
              <a:gd name="connsiteX14" fmla="*/ 1757778 w 2432481"/>
              <a:gd name="connsiteY14" fmla="*/ 896644 h 3262542"/>
              <a:gd name="connsiteX15" fmla="*/ 2024108 w 2432481"/>
              <a:gd name="connsiteY15" fmla="*/ 2201661 h 3262542"/>
              <a:gd name="connsiteX16" fmla="*/ 2219417 w 2432481"/>
              <a:gd name="connsiteY16" fmla="*/ 1553591 h 3262542"/>
              <a:gd name="connsiteX17" fmla="*/ 2432481 w 2432481"/>
              <a:gd name="connsiteY17" fmla="*/ 1997475 h 32625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2432481" h="3262542">
                <a:moveTo>
                  <a:pt x="0" y="1935331"/>
                </a:moveTo>
                <a:cubicBezTo>
                  <a:pt x="31811" y="1998954"/>
                  <a:pt x="63623" y="2062578"/>
                  <a:pt x="79899" y="2024108"/>
                </a:cubicBezTo>
                <a:cubicBezTo>
                  <a:pt x="96175" y="1985638"/>
                  <a:pt x="76940" y="1710430"/>
                  <a:pt x="97654" y="1704512"/>
                </a:cubicBezTo>
                <a:cubicBezTo>
                  <a:pt x="118368" y="1698594"/>
                  <a:pt x="174594" y="2004873"/>
                  <a:pt x="204186" y="1988597"/>
                </a:cubicBezTo>
                <a:cubicBezTo>
                  <a:pt x="233778" y="1972321"/>
                  <a:pt x="242655" y="1546193"/>
                  <a:pt x="275207" y="1606857"/>
                </a:cubicBezTo>
                <a:cubicBezTo>
                  <a:pt x="307759" y="1667521"/>
                  <a:pt x="352147" y="2456155"/>
                  <a:pt x="399495" y="2352582"/>
                </a:cubicBezTo>
                <a:cubicBezTo>
                  <a:pt x="446843" y="2249009"/>
                  <a:pt x="516384" y="1037206"/>
                  <a:pt x="559293" y="985420"/>
                </a:cubicBezTo>
                <a:cubicBezTo>
                  <a:pt x="602202" y="933634"/>
                  <a:pt x="603681" y="2177987"/>
                  <a:pt x="656947" y="2041863"/>
                </a:cubicBezTo>
                <a:cubicBezTo>
                  <a:pt x="710213" y="1905739"/>
                  <a:pt x="810827" y="0"/>
                  <a:pt x="878889" y="168675"/>
                </a:cubicBezTo>
                <a:cubicBezTo>
                  <a:pt x="946951" y="337350"/>
                  <a:pt x="1006136" y="2845292"/>
                  <a:pt x="1065320" y="3053917"/>
                </a:cubicBezTo>
                <a:cubicBezTo>
                  <a:pt x="1124504" y="3262542"/>
                  <a:pt x="1188128" y="1562469"/>
                  <a:pt x="1233996" y="1420426"/>
                </a:cubicBezTo>
                <a:cubicBezTo>
                  <a:pt x="1279864" y="1278383"/>
                  <a:pt x="1306497" y="2136558"/>
                  <a:pt x="1340528" y="2201661"/>
                </a:cubicBezTo>
                <a:cubicBezTo>
                  <a:pt x="1374559" y="2266764"/>
                  <a:pt x="1398233" y="1751860"/>
                  <a:pt x="1438182" y="1811044"/>
                </a:cubicBezTo>
                <a:cubicBezTo>
                  <a:pt x="1478132" y="1870229"/>
                  <a:pt x="1526959" y="2709168"/>
                  <a:pt x="1580225" y="2556768"/>
                </a:cubicBezTo>
                <a:cubicBezTo>
                  <a:pt x="1633491" y="2404368"/>
                  <a:pt x="1683798" y="955828"/>
                  <a:pt x="1757778" y="896644"/>
                </a:cubicBezTo>
                <a:cubicBezTo>
                  <a:pt x="1831758" y="837460"/>
                  <a:pt x="1947168" y="2092170"/>
                  <a:pt x="2024108" y="2201661"/>
                </a:cubicBezTo>
                <a:cubicBezTo>
                  <a:pt x="2101048" y="2311152"/>
                  <a:pt x="2151355" y="1587622"/>
                  <a:pt x="2219417" y="1553591"/>
                </a:cubicBezTo>
                <a:cubicBezTo>
                  <a:pt x="2287479" y="1519560"/>
                  <a:pt x="2359980" y="1758517"/>
                  <a:pt x="2432481" y="1997475"/>
                </a:cubicBezTo>
              </a:path>
            </a:pathLst>
          </a:cu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0"/>
                            </p:stCondLst>
                            <p:childTnLst>
                              <p:par>
                                <p:cTn id="8" presetID="8" presetClass="emph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9" dur="2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0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1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2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3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4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5" dur="2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6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7" dur="2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8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9" dur="2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0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1" dur="2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2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3" dur="2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4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5" dur="2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6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0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8" presetClass="emph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Rot by="27000000">
                                      <p:cBhvr>
                                        <p:cTn id="40" dur="2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7000000">
                                      <p:cBhvr>
                                        <p:cTn id="42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7000000">
                                      <p:cBhvr>
                                        <p:cTn id="44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46" dur="2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48" dur="2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50" dur="2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16200000">
                                      <p:cBhvr>
                                        <p:cTn id="52" dur="2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3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16200000">
                                      <p:cBhvr>
                                        <p:cTn id="54" dur="2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5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16200000">
                                      <p:cBhvr>
                                        <p:cTn id="56" dur="2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0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8" dur="2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69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0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1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2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3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4" dur="2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5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6" dur="2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7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8" dur="2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9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80" dur="2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81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82" dur="2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83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84" dur="2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5" fill="hold">
                      <p:stCondLst>
                        <p:cond delay="indefinite"/>
                      </p:stCondLst>
                      <p:childTnLst>
                        <p:par>
                          <p:cTn id="86" fill="hold">
                            <p:stCondLst>
                              <p:cond delay="0"/>
                            </p:stCondLst>
                            <p:childTnLst>
                              <p:par>
                                <p:cTn id="87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presetID="1" presetClass="exit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7" fill="hold">
                            <p:stCondLst>
                              <p:cond delay="0"/>
                            </p:stCondLst>
                            <p:childTnLst>
                              <p:par>
                                <p:cTn id="98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0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0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2" fill="hold">
                      <p:stCondLst>
                        <p:cond delay="indefinite"/>
                      </p:stCondLst>
                      <p:childTnLst>
                        <p:par>
                          <p:cTn id="103" fill="hold">
                            <p:stCondLst>
                              <p:cond delay="0"/>
                            </p:stCondLst>
                            <p:childTnLst>
                              <p:par>
                                <p:cTn id="104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6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8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0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2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4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6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8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0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2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4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8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8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4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45" dur="2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46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47" dur="20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48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49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0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43200000">
                                      <p:cBhvr>
                                        <p:cTn id="151" dur="2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2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43200000">
                                      <p:cBhvr>
                                        <p:cTn id="153" dur="20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4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43200000">
                                      <p:cBhvr>
                                        <p:cTn id="155" dur="2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6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86400000">
                                      <p:cBhvr>
                                        <p:cTn id="157" dur="200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8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86400000">
                                      <p:cBhvr>
                                        <p:cTn id="159" dur="2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60" presetID="8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86400000">
                                      <p:cBhvr>
                                        <p:cTn id="161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62" presetID="22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64" dur="2000"/>
                                        <p:tgtEl>
                                          <p:spTgt spid="14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5" presetID="22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67" dur="2000"/>
                                        <p:tgtEl>
                                          <p:spTgt spid="1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8" presetID="22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70" dur="2000"/>
                                        <p:tgtEl>
                                          <p:spTgt spid="1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1" fill="hold">
                      <p:stCondLst>
                        <p:cond delay="indefinite"/>
                      </p:stCondLst>
                      <p:childTnLst>
                        <p:par>
                          <p:cTn id="172" fill="hold">
                            <p:stCondLst>
                              <p:cond delay="0"/>
                            </p:stCondLst>
                            <p:childTnLst>
                              <p:par>
                                <p:cTn id="173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9" fill="hold">
                            <p:stCondLst>
                              <p:cond delay="0"/>
                            </p:stCondLst>
                            <p:childTnLst>
                              <p:par>
                                <p:cTn id="180" presetID="63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6 -2.75503E-6 L 0.49913 0.00301 " pathEditMode="relative" rAng="0" ptsTypes="AA">
                                      <p:cBhvr>
                                        <p:cTn id="181" dur="2000" fill="hold"/>
                                        <p:tgtEl>
                                          <p:spTgt spid="13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49" y="1"/>
                                    </p:animMotion>
                                  </p:childTnLst>
                                </p:cTn>
                              </p:par>
                              <p:par>
                                <p:cTn id="182" presetID="63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88889E-6 4.60328E-6 L 0.40781 0.00254 " pathEditMode="relative" rAng="0" ptsTypes="AA">
                                      <p:cBhvr>
                                        <p:cTn id="183" dur="2000" fill="hold"/>
                                        <p:tgtEl>
                                          <p:spTgt spid="1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04" y="1"/>
                                    </p:animMotion>
                                  </p:childTnLst>
                                </p:cTn>
                              </p:par>
                              <p:par>
                                <p:cTn id="184" presetID="63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4.16667E-6 -4.45524E-6 L 0.31215 -0.00254 " pathEditMode="relative" rAng="0" ptsTypes="AA">
                                      <p:cBhvr>
                                        <p:cTn id="185" dur="2000" fill="hold"/>
                                        <p:tgtEl>
                                          <p:spTgt spid="14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56" y="-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6" fill="hold">
                            <p:stCondLst>
                              <p:cond delay="2000"/>
                            </p:stCondLst>
                            <p:childTnLst>
                              <p:par>
                                <p:cTn id="187" presetID="1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9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1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92" dur="1000"/>
                                        <p:tgtEl>
                                          <p:spTgt spid="14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3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1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4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96" dur="2000"/>
                                        <p:tgtEl>
                                          <p:spTgt spid="1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3053" grpId="0" animBg="1"/>
      <p:bldP spid="43053" grpId="1" animBg="1"/>
      <p:bldP spid="43073" grpId="0" animBg="1"/>
      <p:bldP spid="43115" grpId="0"/>
      <p:bldP spid="129" grpId="0" animBg="1"/>
      <p:bldP spid="114" grpId="0" animBg="1"/>
      <p:bldP spid="114" grpId="1" animBg="1"/>
      <p:bldP spid="115" grpId="0" animBg="1"/>
      <p:bldP spid="115" grpId="1" animBg="1"/>
      <p:bldP spid="116" grpId="0" animBg="1"/>
      <p:bldP spid="116" grpId="1" animBg="1"/>
      <p:bldP spid="117" grpId="0" animBg="1"/>
      <p:bldP spid="117" grpId="1" animBg="1"/>
      <p:bldP spid="118" grpId="0" animBg="1"/>
      <p:bldP spid="118" grpId="1" animBg="1"/>
      <p:bldP spid="119" grpId="0" animBg="1"/>
      <p:bldP spid="120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</TotalTime>
  <Words>120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DB</dc:creator>
  <cp:lastModifiedBy>jpr</cp:lastModifiedBy>
  <cp:revision>23</cp:revision>
  <dcterms:created xsi:type="dcterms:W3CDTF">2010-11-11T10:20:49Z</dcterms:created>
  <dcterms:modified xsi:type="dcterms:W3CDTF">2010-11-12T13:33:49Z</dcterms:modified>
</cp:coreProperties>
</file>